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jpe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60" r:id="rId2"/>
  </p:sldIdLst>
  <p:sldSz cx="6858000" cy="9906000" type="A4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08"/>
    <p:restoredTop sz="94679"/>
  </p:normalViewPr>
  <p:slideViewPr>
    <p:cSldViewPr snapToGrid="0" snapToObjects="1" showGuides="1">
      <p:cViewPr varScale="1">
        <p:scale>
          <a:sx n="61" d="100"/>
          <a:sy n="61" d="100"/>
        </p:scale>
        <p:origin x="2920" y="216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4" Type="http://schemas.openxmlformats.org/officeDocument/2006/relationships/viewProps" Target="viewProps.xml"/><Relationship Id="rId5" Type="http://schemas.openxmlformats.org/officeDocument/2006/relationships/theme" Target="theme/theme1.xml"/><Relationship Id="rId6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CEF798-C78A-0347-BF8A-A0A354A795C2}" type="datetimeFigureOut">
              <a:rPr lang="en-US" smtClean="0"/>
              <a:t>2/14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C969C2-3D3F-4842-8749-B4432BB66964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CEF798-C78A-0347-BF8A-A0A354A795C2}" type="datetimeFigureOut">
              <a:rPr lang="en-US" smtClean="0"/>
              <a:t>2/14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C969C2-3D3F-4842-8749-B4432BB66964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CEF798-C78A-0347-BF8A-A0A354A795C2}" type="datetimeFigureOut">
              <a:rPr lang="en-US" smtClean="0"/>
              <a:t>2/14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C969C2-3D3F-4842-8749-B4432BB66964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CEF798-C78A-0347-BF8A-A0A354A795C2}" type="datetimeFigureOut">
              <a:rPr lang="en-US" smtClean="0"/>
              <a:t>2/14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C969C2-3D3F-4842-8749-B4432BB66964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CEF798-C78A-0347-BF8A-A0A354A795C2}" type="datetimeFigureOut">
              <a:rPr lang="en-US" smtClean="0"/>
              <a:t>2/14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C969C2-3D3F-4842-8749-B4432BB66964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CEF798-C78A-0347-BF8A-A0A354A795C2}" type="datetimeFigureOut">
              <a:rPr lang="en-US" smtClean="0"/>
              <a:t>2/14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C969C2-3D3F-4842-8749-B4432BB66964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CEF798-C78A-0347-BF8A-A0A354A795C2}" type="datetimeFigureOut">
              <a:rPr lang="en-US" smtClean="0"/>
              <a:t>2/14/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C969C2-3D3F-4842-8749-B4432BB66964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CEF798-C78A-0347-BF8A-A0A354A795C2}" type="datetimeFigureOut">
              <a:rPr lang="en-US" smtClean="0"/>
              <a:t>2/14/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C969C2-3D3F-4842-8749-B4432BB66964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CEF798-C78A-0347-BF8A-A0A354A795C2}" type="datetimeFigureOut">
              <a:rPr lang="en-US" smtClean="0"/>
              <a:t>2/14/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C969C2-3D3F-4842-8749-B4432BB66964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CEF798-C78A-0347-BF8A-A0A354A795C2}" type="datetimeFigureOut">
              <a:rPr lang="en-US" smtClean="0"/>
              <a:t>2/14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C969C2-3D3F-4842-8749-B4432BB66964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smtClean="0"/>
              <a:t>Drag picture to placeholder or click icon to add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CEF798-C78A-0347-BF8A-A0A354A795C2}" type="datetimeFigureOut">
              <a:rPr lang="en-US" smtClean="0"/>
              <a:t>2/14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C969C2-3D3F-4842-8749-B4432BB66964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0CEF798-C78A-0347-BF8A-A0A354A795C2}" type="datetimeFigureOut">
              <a:rPr lang="en-US" smtClean="0"/>
              <a:t>2/14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CC969C2-3D3F-4842-8749-B4432BB669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5980648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Table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921718486"/>
              </p:ext>
            </p:extLst>
          </p:nvPr>
        </p:nvGraphicFramePr>
        <p:xfrm>
          <a:off x="755542" y="3572322"/>
          <a:ext cx="5672379" cy="3408763"/>
        </p:xfrm>
        <a:graphic>
          <a:graphicData uri="http://schemas.openxmlformats.org/drawingml/2006/table">
            <a:tbl>
              <a:tblPr firstRow="1" firstCol="1" bandRow="1">
                <a:tableStyleId>{5940675A-B579-460E-94D1-54222C63F5DA}</a:tableStyleId>
              </a:tblPr>
              <a:tblGrid>
                <a:gridCol w="1026313"/>
                <a:gridCol w="702412"/>
                <a:gridCol w="758753"/>
                <a:gridCol w="646071"/>
                <a:gridCol w="702412"/>
                <a:gridCol w="702412"/>
                <a:gridCol w="1134006"/>
              </a:tblGrid>
              <a:tr h="556213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200" u="none" strike="noStrike">
                          <a:effectLst/>
                        </a:rPr>
                        <a:t>Study 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7144" marR="7144" marT="7144" marB="0" anchor="ctr"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200" u="none" strike="noStrike">
                          <a:effectLst/>
                        </a:rPr>
                        <a:t>Number in Lineage 2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7144" marR="7144" marT="7144" marB="0" anchor="ctr"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200" u="none" strike="noStrike">
                          <a:effectLst/>
                        </a:rPr>
                        <a:t>Percentage of Lineage 2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7144" marR="7144" marT="7144" marB="0" anchor="ctr"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200" u="none" strike="noStrike">
                          <a:effectLst/>
                        </a:rPr>
                        <a:t>Number in Lineage 4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7144" marR="7144" marT="7144" marB="0" anchor="ctr"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200" u="none" strike="noStrike">
                          <a:effectLst/>
                        </a:rPr>
                        <a:t>Percentage of Lineage 4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7144" marR="7144" marT="7144" marB="0" anchor="ctr"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200" u="none" strike="noStrike">
                          <a:effectLst/>
                        </a:rPr>
                        <a:t>Total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7144" marR="7144" marT="7144" marB="0" anchor="ctr"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200" u="none" strike="noStrike">
                          <a:effectLst/>
                        </a:rPr>
                        <a:t>Percentage of Total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7144" marR="7144" marT="7144" marB="0" anchor="ctr"/>
                </a:tc>
              </a:tr>
              <a:tr h="190170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200" u="none" strike="noStrike">
                          <a:effectLst/>
                        </a:rPr>
                        <a:t>Brazil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7144" marR="7144" marT="7144" marB="0" anchor="ctr"/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sz="1200" u="none" strike="noStrike">
                          <a:effectLst/>
                        </a:rPr>
                        <a:t>0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7144" marR="7144" marT="7144" marB="0" anchor="ctr"/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sz="1200" u="none" strike="noStrike" dirty="0" smtClean="0">
                          <a:effectLst/>
                        </a:rPr>
                        <a:t>0.0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7144" marR="7144" marT="7144" marB="0" anchor="ctr"/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sz="1200" u="none" strike="noStrike">
                          <a:effectLst/>
                        </a:rPr>
                        <a:t>92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7144" marR="7144" marT="7144" marB="0" anchor="ctr"/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sz="1200" u="none" strike="noStrike" dirty="0" smtClean="0">
                          <a:effectLst/>
                        </a:rPr>
                        <a:t>2.5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7144" marR="7144" marT="7144" marB="0" anchor="ctr"/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sz="1200" u="none" strike="noStrike">
                          <a:effectLst/>
                        </a:rPr>
                        <a:t>92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7144" marR="7144" marT="7144" marB="0" anchor="ctr"/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sz="1200" u="none" strike="noStrike" dirty="0" smtClean="0">
                          <a:effectLst/>
                        </a:rPr>
                        <a:t>2.1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7144" marR="7144" marT="7144" marB="0" anchor="ctr"/>
                </a:tc>
              </a:tr>
              <a:tr h="190170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200" u="none" strike="noStrike">
                          <a:effectLst/>
                        </a:rPr>
                        <a:t>China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7144" marR="7144" marT="7144" marB="0" anchor="ctr"/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sz="1200" u="none" strike="noStrike">
                          <a:effectLst/>
                        </a:rPr>
                        <a:t>122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7144" marR="7144" marT="7144" marB="0" anchor="ctr"/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sz="1200" u="none" strike="noStrike" dirty="0" smtClean="0">
                          <a:effectLst/>
                        </a:rPr>
                        <a:t>17.4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7144" marR="7144" marT="7144" marB="0" anchor="ctr"/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sz="1200" u="none" strike="noStrike">
                          <a:effectLst/>
                        </a:rPr>
                        <a:t>37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7144" marR="7144" marT="7144" marB="0" anchor="ctr"/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sz="1200" u="none" strike="noStrike" dirty="0" smtClean="0">
                          <a:effectLst/>
                        </a:rPr>
                        <a:t>1.0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7144" marR="7144" marT="7144" marB="0" anchor="ctr"/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sz="1200" u="none" strike="noStrike">
                          <a:effectLst/>
                        </a:rPr>
                        <a:t>159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7144" marR="7144" marT="7144" marB="0" anchor="ctr"/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sz="1200" u="none" strike="noStrike" dirty="0" smtClean="0">
                          <a:effectLst/>
                        </a:rPr>
                        <a:t>3.6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7144" marR="7144" marT="7144" marB="0" anchor="ctr"/>
                </a:tc>
              </a:tr>
              <a:tr h="190170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200" u="none" strike="noStrike">
                          <a:effectLst/>
                        </a:rPr>
                        <a:t>South Africa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7144" marR="7144" marT="7144" marB="0" anchor="ctr"/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sz="1200" u="none" strike="noStrike">
                          <a:effectLst/>
                        </a:rPr>
                        <a:t>127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7144" marR="7144" marT="7144" marB="0" anchor="ctr"/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sz="1200" u="none" strike="noStrike" dirty="0" smtClean="0">
                          <a:effectLst/>
                        </a:rPr>
                        <a:t>18.1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7144" marR="7144" marT="7144" marB="0" anchor="ctr"/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sz="1200" u="none" strike="noStrike">
                          <a:effectLst/>
                        </a:rPr>
                        <a:t>320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7144" marR="7144" marT="7144" marB="0" anchor="ctr"/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sz="1200" u="none" strike="noStrike" dirty="0" smtClean="0">
                          <a:effectLst/>
                        </a:rPr>
                        <a:t>8.6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7144" marR="7144" marT="7144" marB="0" anchor="ctr"/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sz="1200" u="none" strike="noStrike">
                          <a:effectLst/>
                        </a:rPr>
                        <a:t>447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7144" marR="7144" marT="7144" marB="0" anchor="ctr"/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sz="1200" u="none" strike="noStrike" dirty="0" smtClean="0">
                          <a:effectLst/>
                        </a:rPr>
                        <a:t>10.1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7144" marR="7144" marT="7144" marB="0" anchor="ctr"/>
                </a:tc>
              </a:tr>
              <a:tr h="190170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200" u="none" strike="noStrike">
                          <a:effectLst/>
                        </a:rPr>
                        <a:t>Columbia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7144" marR="7144" marT="7144" marB="0" anchor="ctr"/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sz="1200" u="none" strike="noStrike">
                          <a:effectLst/>
                        </a:rPr>
                        <a:t>0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7144" marR="7144" marT="7144" marB="0" anchor="ctr"/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sz="1200" u="none" strike="noStrike" dirty="0" smtClean="0">
                          <a:effectLst/>
                        </a:rPr>
                        <a:t>0.0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7144" marR="7144" marT="7144" marB="0" anchor="ctr"/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sz="1200" u="none" strike="noStrike">
                          <a:effectLst/>
                        </a:rPr>
                        <a:t>15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7144" marR="7144" marT="7144" marB="0" anchor="ctr"/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sz="1200" u="none" strike="noStrike" dirty="0" smtClean="0">
                          <a:effectLst/>
                        </a:rPr>
                        <a:t>0.4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7144" marR="7144" marT="7144" marB="0" anchor="ctr"/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sz="1200" u="none" strike="noStrike">
                          <a:effectLst/>
                        </a:rPr>
                        <a:t>15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7144" marR="7144" marT="7144" marB="0" anchor="ctr"/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sz="1200" u="none" strike="noStrike" dirty="0" smtClean="0">
                          <a:effectLst/>
                        </a:rPr>
                        <a:t>0.3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7144" marR="7144" marT="7144" marB="0" anchor="ctr"/>
                </a:tc>
              </a:tr>
              <a:tr h="190170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200" u="none" strike="noStrike">
                          <a:effectLst/>
                        </a:rPr>
                        <a:t>Mixed**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7144" marR="7144" marT="7144" marB="0" anchor="ctr"/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sz="1200" u="none" strike="noStrike">
                          <a:effectLst/>
                        </a:rPr>
                        <a:t>38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7144" marR="7144" marT="7144" marB="0" anchor="ctr"/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sz="1200" u="none" strike="noStrike" dirty="0" smtClean="0">
                          <a:effectLst/>
                        </a:rPr>
                        <a:t>5.4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7144" marR="7144" marT="7144" marB="0" anchor="ctr"/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sz="1200" u="none" strike="noStrike">
                          <a:effectLst/>
                        </a:rPr>
                        <a:t>50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7144" marR="7144" marT="7144" marB="0" anchor="ctr"/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sz="1200" u="none" strike="noStrike" dirty="0" smtClean="0">
                          <a:effectLst/>
                        </a:rPr>
                        <a:t>1.4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7144" marR="7144" marT="7144" marB="0" anchor="ctr"/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sz="1200" u="none" strike="noStrike">
                          <a:effectLst/>
                        </a:rPr>
                        <a:t>88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7144" marR="7144" marT="7144" marB="0" anchor="ctr"/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sz="1200" u="none" strike="noStrike" dirty="0" smtClean="0">
                          <a:effectLst/>
                        </a:rPr>
                        <a:t>2.0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7144" marR="7144" marT="7144" marB="0" anchor="ctr"/>
                </a:tc>
              </a:tr>
              <a:tr h="190170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200" u="none" strike="noStrike">
                          <a:effectLst/>
                        </a:rPr>
                        <a:t>Germany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7144" marR="7144" marT="7144" marB="0" anchor="ctr"/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sz="1200" u="none" strike="noStrike">
                          <a:effectLst/>
                        </a:rPr>
                        <a:t>0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7144" marR="7144" marT="7144" marB="0" anchor="ctr"/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sz="1200" u="none" strike="noStrike" dirty="0" smtClean="0">
                          <a:effectLst/>
                        </a:rPr>
                        <a:t>0.0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7144" marR="7144" marT="7144" marB="0" anchor="ctr"/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sz="1200" u="none" strike="noStrike">
                          <a:effectLst/>
                        </a:rPr>
                        <a:t>20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7144" marR="7144" marT="7144" marB="0" anchor="ctr"/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sz="1200" u="none" strike="noStrike" dirty="0" smtClean="0">
                          <a:effectLst/>
                        </a:rPr>
                        <a:t>0.5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7144" marR="7144" marT="7144" marB="0" anchor="ctr"/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sz="1200" u="none" strike="noStrike">
                          <a:effectLst/>
                        </a:rPr>
                        <a:t>20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7144" marR="7144" marT="7144" marB="0" anchor="ctr"/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sz="1200" u="none" strike="noStrike" dirty="0" smtClean="0">
                          <a:effectLst/>
                        </a:rPr>
                        <a:t>0.5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7144" marR="7144" marT="7144" marB="0" anchor="ctr"/>
                </a:tc>
              </a:tr>
              <a:tr h="190170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200" u="none" strike="noStrike">
                          <a:effectLst/>
                        </a:rPr>
                        <a:t>Pakistan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7144" marR="7144" marT="7144" marB="0" anchor="ctr"/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sz="1200" u="none" strike="noStrike">
                          <a:effectLst/>
                        </a:rPr>
                        <a:t>0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7144" marR="7144" marT="7144" marB="0" anchor="ctr"/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sz="1200" u="none" strike="noStrike" dirty="0" smtClean="0">
                          <a:effectLst/>
                        </a:rPr>
                        <a:t>0.0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7144" marR="7144" marT="7144" marB="0" anchor="ctr"/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sz="1200" u="none" strike="noStrike">
                          <a:effectLst/>
                        </a:rPr>
                        <a:t>4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7144" marR="7144" marT="7144" marB="0" anchor="ctr"/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sz="1200" u="none" strike="noStrike" dirty="0" smtClean="0">
                          <a:effectLst/>
                        </a:rPr>
                        <a:t>0.1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7144" marR="7144" marT="7144" marB="0" anchor="ctr"/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sz="1200" u="none" strike="noStrike">
                          <a:effectLst/>
                        </a:rPr>
                        <a:t>4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7144" marR="7144" marT="7144" marB="0" anchor="ctr"/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sz="1200" u="none" strike="noStrike" dirty="0" smtClean="0">
                          <a:effectLst/>
                        </a:rPr>
                        <a:t>0.1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7144" marR="7144" marT="7144" marB="0" anchor="ctr"/>
                </a:tc>
              </a:tr>
              <a:tr h="190170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200" u="none" strike="noStrike">
                          <a:effectLst/>
                        </a:rPr>
                        <a:t>Malawi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7144" marR="7144" marT="7144" marB="0" anchor="ctr"/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sz="1200" u="none" strike="noStrike">
                          <a:effectLst/>
                        </a:rPr>
                        <a:t>7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7144" marR="7144" marT="7144" marB="0" anchor="ctr"/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sz="1200" u="none" strike="noStrike" dirty="0" smtClean="0">
                          <a:effectLst/>
                        </a:rPr>
                        <a:t>10.1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7144" marR="7144" marT="7144" marB="0" anchor="ctr"/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sz="1200" u="none" strike="noStrike">
                          <a:effectLst/>
                        </a:rPr>
                        <a:t>1116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7144" marR="7144" marT="7144" marB="0" anchor="ctr"/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sz="1200" u="none" strike="noStrike" dirty="0" smtClean="0">
                          <a:effectLst/>
                        </a:rPr>
                        <a:t>30.1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7144" marR="7144" marT="7144" marB="0" anchor="ctr"/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sz="1200" u="none" strike="noStrike">
                          <a:effectLst/>
                        </a:rPr>
                        <a:t>1187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7144" marR="7144" marT="7144" marB="0" anchor="ctr"/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sz="1200" u="none" strike="noStrike" dirty="0" smtClean="0">
                          <a:effectLst/>
                        </a:rPr>
                        <a:t>26.9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7144" marR="7144" marT="7144" marB="0" anchor="ctr"/>
                </a:tc>
              </a:tr>
              <a:tr h="190170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200" u="none" strike="noStrike">
                          <a:effectLst/>
                        </a:rPr>
                        <a:t>Lisbon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7144" marR="7144" marT="7144" marB="0" anchor="ctr"/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sz="1200" u="none" strike="noStrike">
                          <a:effectLst/>
                        </a:rPr>
                        <a:t>5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7144" marR="7144" marT="7144" marB="0" anchor="ctr"/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sz="1200" u="none" strike="noStrike" dirty="0" smtClean="0">
                          <a:effectLst/>
                        </a:rPr>
                        <a:t>0.7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7144" marR="7144" marT="7144" marB="0" anchor="ctr"/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sz="1200" u="none" strike="noStrike">
                          <a:effectLst/>
                        </a:rPr>
                        <a:t>73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7144" marR="7144" marT="7144" marB="0" anchor="ctr"/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sz="1200" u="none" strike="noStrike" dirty="0" smtClean="0">
                          <a:effectLst/>
                        </a:rPr>
                        <a:t>2.0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7144" marR="7144" marT="7144" marB="0" anchor="ctr"/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sz="1200" u="none" strike="noStrike">
                          <a:effectLst/>
                        </a:rPr>
                        <a:t>78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7144" marR="7144" marT="7144" marB="0" anchor="ctr"/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sz="1200" u="none" strike="noStrike" dirty="0" smtClean="0">
                          <a:effectLst/>
                        </a:rPr>
                        <a:t>1.8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7144" marR="7144" marT="7144" marB="0" anchor="ctr"/>
                </a:tc>
              </a:tr>
              <a:tr h="190170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200" u="none" strike="noStrike">
                          <a:effectLst/>
                        </a:rPr>
                        <a:t>Peru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7144" marR="7144" marT="7144" marB="0" anchor="ctr"/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sz="1200" u="none" strike="noStrike">
                          <a:effectLst/>
                        </a:rPr>
                        <a:t>6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7144" marR="7144" marT="7144" marB="0" anchor="ctr"/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sz="1200" u="none" strike="noStrike" dirty="0" smtClean="0">
                          <a:effectLst/>
                        </a:rPr>
                        <a:t>0.9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7144" marR="7144" marT="7144" marB="0" anchor="ctr"/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sz="1200" u="none" strike="noStrike">
                          <a:effectLst/>
                        </a:rPr>
                        <a:t>72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7144" marR="7144" marT="7144" marB="0" anchor="ctr"/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sz="1200" u="none" strike="noStrike" dirty="0" smtClean="0">
                          <a:effectLst/>
                        </a:rPr>
                        <a:t>1.9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7144" marR="7144" marT="7144" marB="0" anchor="ctr"/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sz="1200" u="none" strike="noStrike">
                          <a:effectLst/>
                        </a:rPr>
                        <a:t>78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7144" marR="7144" marT="7144" marB="0" anchor="ctr"/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sz="1200" u="none" strike="noStrike" dirty="0" smtClean="0">
                          <a:effectLst/>
                        </a:rPr>
                        <a:t>1.8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7144" marR="7144" marT="7144" marB="0" anchor="ctr"/>
                </a:tc>
              </a:tr>
              <a:tr h="190170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200" u="none" strike="noStrike">
                          <a:effectLst/>
                        </a:rPr>
                        <a:t>Porto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7144" marR="7144" marT="7144" marB="0" anchor="ctr"/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sz="1200" u="none" strike="noStrike">
                          <a:effectLst/>
                        </a:rPr>
                        <a:t>15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7144" marR="7144" marT="7144" marB="0" anchor="ctr"/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sz="1200" u="none" strike="noStrike" dirty="0" smtClean="0">
                          <a:effectLst/>
                        </a:rPr>
                        <a:t>2.1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7144" marR="7144" marT="7144" marB="0" anchor="ctr"/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sz="1200" u="none" strike="noStrike">
                          <a:effectLst/>
                        </a:rPr>
                        <a:t>116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7144" marR="7144" marT="7144" marB="0" anchor="ctr"/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sz="1200" u="none" strike="noStrike" dirty="0" smtClean="0">
                          <a:effectLst/>
                        </a:rPr>
                        <a:t>3.1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7144" marR="7144" marT="7144" marB="0" anchor="ctr"/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sz="1200" u="none" strike="noStrike">
                          <a:effectLst/>
                        </a:rPr>
                        <a:t>13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7144" marR="7144" marT="7144" marB="0" anchor="ctr"/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sz="1200" u="none" strike="noStrike" dirty="0" smtClean="0">
                          <a:effectLst/>
                        </a:rPr>
                        <a:t>3.0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7144" marR="7144" marT="7144" marB="0" anchor="ctr"/>
                </a:tc>
              </a:tr>
              <a:tr h="190170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200" u="none" strike="noStrike">
                          <a:effectLst/>
                        </a:rPr>
                        <a:t>Russia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7144" marR="7144" marT="7144" marB="0" anchor="ctr"/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sz="1200" u="none" strike="noStrike">
                          <a:effectLst/>
                        </a:rPr>
                        <a:t>2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7144" marR="7144" marT="7144" marB="0" anchor="ctr"/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sz="1200" u="none" strike="noStrike" dirty="0" smtClean="0">
                          <a:effectLst/>
                        </a:rPr>
                        <a:t>0.3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7144" marR="7144" marT="7144" marB="0" anchor="ctr"/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sz="1200" u="none" strike="noStrike">
                          <a:effectLst/>
                        </a:rPr>
                        <a:t>0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7144" marR="7144" marT="7144" marB="0" anchor="ctr"/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sz="1200" u="none" strike="noStrike" dirty="0" smtClean="0">
                          <a:effectLst/>
                        </a:rPr>
                        <a:t>0.0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7144" marR="7144" marT="7144" marB="0" anchor="ctr"/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sz="1200" u="none" strike="noStrike">
                          <a:effectLst/>
                        </a:rPr>
                        <a:t>2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7144" marR="7144" marT="7144" marB="0" anchor="ctr"/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sz="1200" u="none" strike="noStrike" dirty="0" smtClean="0">
                          <a:effectLst/>
                        </a:rPr>
                        <a:t>0.1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7144" marR="7144" marT="7144" marB="0" anchor="ctr"/>
                </a:tc>
              </a:tr>
              <a:tr h="190170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200" u="none" strike="noStrike">
                          <a:effectLst/>
                        </a:rPr>
                        <a:t>Vietnam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7144" marR="7144" marT="7144" marB="0" anchor="ctr"/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sz="1200" u="none" strike="noStrike">
                          <a:effectLst/>
                        </a:rPr>
                        <a:t>19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7144" marR="7144" marT="7144" marB="0" anchor="ctr"/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sz="1200" u="none" strike="noStrike" dirty="0" smtClean="0">
                          <a:effectLst/>
                        </a:rPr>
                        <a:t>2.7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7144" marR="7144" marT="7144" marB="0" anchor="ctr"/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sz="1200" u="none" strike="noStrike">
                          <a:effectLst/>
                        </a:rPr>
                        <a:t>8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7144" marR="7144" marT="7144" marB="0" anchor="ctr"/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sz="1200" u="none" strike="noStrike" dirty="0" smtClean="0">
                          <a:effectLst/>
                        </a:rPr>
                        <a:t>0.2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7144" marR="7144" marT="7144" marB="0" anchor="ctr"/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sz="1200" u="none" strike="noStrike">
                          <a:effectLst/>
                        </a:rPr>
                        <a:t>27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7144" marR="7144" marT="7144" marB="0" anchor="ctr"/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sz="1200" u="none" strike="noStrike" dirty="0" smtClean="0">
                          <a:effectLst/>
                        </a:rPr>
                        <a:t>0.6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7144" marR="7144" marT="7144" marB="0" anchor="ctr"/>
                </a:tc>
              </a:tr>
              <a:tr h="190170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200" u="none" strike="noStrike">
                          <a:effectLst/>
                        </a:rPr>
                        <a:t>UK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7144" marR="7144" marT="7144" marB="0" anchor="ctr"/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sz="1200" u="none" strike="noStrike">
                          <a:effectLst/>
                        </a:rPr>
                        <a:t>263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7144" marR="7144" marT="7144" marB="0" anchor="ctr"/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sz="1200" u="none" strike="noStrike" dirty="0" smtClean="0">
                          <a:effectLst/>
                        </a:rPr>
                        <a:t>37.5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7144" marR="7144" marT="7144" marB="0" anchor="ctr"/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sz="1200" u="none" strike="noStrike">
                          <a:effectLst/>
                        </a:rPr>
                        <a:t>1697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7144" marR="7144" marT="7144" marB="0" anchor="ctr"/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sz="1200" u="none" strike="noStrike" dirty="0" smtClean="0">
                          <a:effectLst/>
                        </a:rPr>
                        <a:t>45.8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7144" marR="7144" marT="7144" marB="0" anchor="ctr"/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sz="1200" u="none" strike="noStrike">
                          <a:effectLst/>
                        </a:rPr>
                        <a:t>1960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7144" marR="7144" marT="7144" marB="0" anchor="ctr"/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sz="1200" u="none" strike="noStrike" dirty="0" smtClean="0">
                          <a:effectLst/>
                        </a:rPr>
                        <a:t>44.5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7144" marR="7144" marT="7144" marB="0" anchor="ctr"/>
                </a:tc>
              </a:tr>
              <a:tr h="190170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200" u="none" strike="noStrike">
                          <a:effectLst/>
                        </a:rPr>
                        <a:t>WHO*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7144" marR="7144" marT="7144" marB="0" anchor="ctr"/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sz="1200" u="none" strike="noStrike" dirty="0">
                          <a:effectLst/>
                        </a:rPr>
                        <a:t>34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7144" marR="7144" marT="7144" marB="0" anchor="ctr"/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sz="1200" u="none" strike="noStrike" dirty="0" smtClean="0">
                          <a:effectLst/>
                        </a:rPr>
                        <a:t>4.8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7144" marR="7144" marT="7144" marB="0" anchor="ctr"/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sz="1200" u="none" strike="noStrike">
                          <a:effectLst/>
                        </a:rPr>
                        <a:t>86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7144" marR="7144" marT="7144" marB="0" anchor="ctr"/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sz="1200" u="none" strike="noStrike" dirty="0" smtClean="0">
                          <a:effectLst/>
                        </a:rPr>
                        <a:t>2.3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7144" marR="7144" marT="7144" marB="0" anchor="ctr"/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sz="1200" u="none" strike="noStrike">
                          <a:effectLst/>
                        </a:rPr>
                        <a:t>120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7144" marR="7144" marT="7144" marB="0" anchor="ctr"/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sz="1200" u="none" strike="noStrike" dirty="0" smtClean="0">
                          <a:effectLst/>
                        </a:rPr>
                        <a:t>2.7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7144" marR="7144" marT="7144" marB="0" anchor="ctr"/>
                </a:tc>
              </a:tr>
            </a:tbl>
          </a:graphicData>
        </a:graphic>
      </p:graphicFrame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634220" y="2348508"/>
            <a:ext cx="5915025" cy="2447628"/>
          </a:xfrm>
        </p:spPr>
        <p:txBody>
          <a:bodyPr>
            <a:normAutofit/>
          </a:bodyPr>
          <a:lstStyle/>
          <a:p>
            <a:pPr marL="0" indent="0">
              <a:lnSpc>
                <a:spcPct val="100000"/>
              </a:lnSpc>
              <a:spcBef>
                <a:spcPts val="0"/>
              </a:spcBef>
              <a:buNone/>
            </a:pPr>
            <a:r>
              <a:rPr lang="en-US" sz="1400" dirty="0" smtClean="0"/>
              <a:t>Study frequency table, showing numbers and percentage of strains from each study by lineage.</a:t>
            </a:r>
          </a:p>
          <a:p>
            <a:pPr marL="0" indent="0">
              <a:lnSpc>
                <a:spcPct val="100000"/>
              </a:lnSpc>
              <a:spcBef>
                <a:spcPts val="0"/>
              </a:spcBef>
              <a:buNone/>
              <a:defRPr/>
            </a:pPr>
            <a:endParaRPr lang="en-US" sz="1400" dirty="0"/>
          </a:p>
        </p:txBody>
      </p:sp>
    </p:spTree>
    <p:extLst>
      <p:ext uri="{BB962C8B-B14F-4D97-AF65-F5344CB8AC3E}">
        <p14:creationId xmlns:p14="http://schemas.microsoft.com/office/powerpoint/2010/main" val="245944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</TotalTime>
  <Words>145</Words>
  <Application>Microsoft Macintosh PowerPoint</Application>
  <PresentationFormat>A4 Paper (210x297 mm)</PresentationFormat>
  <Paragraphs>11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Calibri</vt:lpstr>
      <vt:lpstr>Calibri Light</vt:lpstr>
      <vt:lpstr>Arial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5.0028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Oppong, Yaa</dc:creator>
  <cp:lastModifiedBy>Oppong, Yaa</cp:lastModifiedBy>
  <cp:revision>2</cp:revision>
  <dcterms:created xsi:type="dcterms:W3CDTF">2018-02-14T14:03:39Z</dcterms:created>
  <dcterms:modified xsi:type="dcterms:W3CDTF">2018-02-14T14:06:35Z</dcterms:modified>
</cp:coreProperties>
</file>